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287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2681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4051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0606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6346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4566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822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6818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9952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8333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9291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361AC-4C1C-44CD-87DD-F95689D9E2DA}" type="datetimeFigureOut">
              <a:rPr lang="zh-CN" altLang="en-US" smtClean="0"/>
              <a:t>2022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77B54-1B1A-4337-BC41-D8B8A7EBB27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6137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图片 5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1501" y="407726"/>
            <a:ext cx="4712749" cy="4535424"/>
          </a:xfrm>
          <a:prstGeom prst="rect">
            <a:avLst/>
          </a:prstGeom>
        </p:spPr>
      </p:pic>
      <p:sp>
        <p:nvSpPr>
          <p:cNvPr id="57" name="TextBox 23"/>
          <p:cNvSpPr txBox="1"/>
          <p:nvPr/>
        </p:nvSpPr>
        <p:spPr>
          <a:xfrm>
            <a:off x="2958560" y="4813630"/>
            <a:ext cx="74236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 reduction of genes expression profiles in three biological replicates from Stage I (yellow), Stage II (red) Stage III (green) and Stage IV (blue).</a:t>
            </a:r>
          </a:p>
        </p:txBody>
      </p:sp>
    </p:spTree>
    <p:extLst>
      <p:ext uri="{BB962C8B-B14F-4D97-AF65-F5344CB8AC3E}">
        <p14:creationId xmlns:p14="http://schemas.microsoft.com/office/powerpoint/2010/main" val="1137257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3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DPI-110</cp:lastModifiedBy>
  <cp:revision>6</cp:revision>
  <dcterms:created xsi:type="dcterms:W3CDTF">2022-03-01T08:07:23Z</dcterms:created>
  <dcterms:modified xsi:type="dcterms:W3CDTF">2022-09-27T16:23:52Z</dcterms:modified>
</cp:coreProperties>
</file>